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3" r:id="rId5"/>
    <p:sldId id="264" r:id="rId6"/>
    <p:sldId id="265" r:id="rId7"/>
    <p:sldId id="266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浅色样式 1 - 强调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69" d="100"/>
          <a:sy n="69" d="100"/>
        </p:scale>
        <p:origin x="33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30247C-B906-4CE9-9D41-35EBC36BD62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360F742-317C-4110-8DB6-CAF9CDBA67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A1AB7EA-EAD9-4F59-A829-DF3CC7881F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61EC3-6C30-4757-98AB-147BBC8E8FEA}" type="datetimeFigureOut">
              <a:rPr lang="zh-CN" altLang="en-US" smtClean="0"/>
              <a:t>2019/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37A6A2C-47BF-4E40-88E5-BFE7287162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A35B6F-7060-4E85-8743-01FC8AA53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DFE01-0A34-4BDF-86DB-42D91D210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8224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90D4A4-42DF-4BEC-A1D3-9F6FA89CEC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95BA857-3CD8-4A7B-A98F-BF7CA2369D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ED2DC4E-7E82-43ED-833E-B3C429B43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61EC3-6C30-4757-98AB-147BBC8E8FEA}" type="datetimeFigureOut">
              <a:rPr lang="zh-CN" altLang="en-US" smtClean="0"/>
              <a:t>2019/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74EB6D8-2B7B-40B9-8E60-9EFA10FB65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DF33FA-1126-4A58-9E97-42B9C47165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DFE01-0A34-4BDF-86DB-42D91D210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9670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3DE3C3E-8EF8-41C9-9FA3-40FD5E8B42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F1138CA-E1EA-4C00-8A22-1A5EF9D072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0D444AA-6527-4B99-95BA-68F6506B6A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61EC3-6C30-4757-98AB-147BBC8E8FEA}" type="datetimeFigureOut">
              <a:rPr lang="zh-CN" altLang="en-US" smtClean="0"/>
              <a:t>2019/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A41EDE-F8AD-405C-A742-68835D097D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3C6BF1A-810C-485A-9F7F-29278EBE8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DFE01-0A34-4BDF-86DB-42D91D210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90804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EF4AC7-5C3E-48FC-A8A7-58CFFB8764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61C9506-E1E4-4BBB-9F1C-AB5CF53611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60F89A-EE22-4811-97B8-9A4FF82C21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61EC3-6C30-4757-98AB-147BBC8E8FEA}" type="datetimeFigureOut">
              <a:rPr lang="zh-CN" altLang="en-US" smtClean="0"/>
              <a:t>2019/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493631E-2D41-4AED-AB1A-E8555482D7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C1ABEEB-B7AE-40EB-A5E0-81C9F76000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DFE01-0A34-4BDF-86DB-42D91D210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58446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0D69A31-A5B0-439A-AC8B-175B2118FB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E815ECE-D015-4F5E-84FB-F6C2F4E3F3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73BD5C8-C26B-4888-9CD9-0CBBB1FF0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61EC3-6C30-4757-98AB-147BBC8E8FEA}" type="datetimeFigureOut">
              <a:rPr lang="zh-CN" altLang="en-US" smtClean="0"/>
              <a:t>2019/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4E91C0-909D-4BF7-897D-51947DA329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CDE834-787D-4C08-A13D-280577738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DFE01-0A34-4BDF-86DB-42D91D210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27071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03B5BF-A37D-4C84-AEAD-2130317B4A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F476981-33D2-4327-9379-3D3D77D827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C6A6FA6-0973-41C2-A4A1-89564CF54B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B82C172-C286-409C-BDAD-98265BA5F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61EC3-6C30-4757-98AB-147BBC8E8FEA}" type="datetimeFigureOut">
              <a:rPr lang="zh-CN" altLang="en-US" smtClean="0"/>
              <a:t>2019/2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86880BD-302A-4797-AD1B-347765EAA0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57A37D6-5761-41AA-90A0-5D821FF3DF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DFE01-0A34-4BDF-86DB-42D91D210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9177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742C73-8FC9-4A06-9995-23ACE74D76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8BAC368-7A89-42FF-B434-7AD7F31702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BA4A8C8-D690-47DD-8637-8851D8DFEF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76C5377-C77B-4058-A643-8342CB97AE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82D1E71-9BB4-4289-9EE1-B2A093DE7B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3822335-9B98-49D6-BB82-80CB9DBBC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61EC3-6C30-4757-98AB-147BBC8E8FEA}" type="datetimeFigureOut">
              <a:rPr lang="zh-CN" altLang="en-US" smtClean="0"/>
              <a:t>2019/2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156327A-EAAC-42AE-B643-E4C625A513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27B7B63-23ED-4841-BC82-F03C63617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DFE01-0A34-4BDF-86DB-42D91D210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278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BDB5B5-6895-4D25-85E6-3196768F23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45CC5D4-C40D-45DA-B2DA-C08D902E8D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61EC3-6C30-4757-98AB-147BBC8E8FEA}" type="datetimeFigureOut">
              <a:rPr lang="zh-CN" altLang="en-US" smtClean="0"/>
              <a:t>2019/2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90670C8-2569-4B70-8EEB-B8462100DE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3C90A0F-17ED-4654-B3F6-6BAF3B499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DFE01-0A34-4BDF-86DB-42D91D210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3208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8A82311-FAF0-45EE-89F7-EEFC483B95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61EC3-6C30-4757-98AB-147BBC8E8FEA}" type="datetimeFigureOut">
              <a:rPr lang="zh-CN" altLang="en-US" smtClean="0"/>
              <a:t>2019/2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B8BA5B7-6601-4F1C-9F39-783E75B388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D6F21D4-9E9D-44E3-9C43-C0F9BC8209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DFE01-0A34-4BDF-86DB-42D91D210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3415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B600C1-66BF-462A-A15E-6107B1AFEB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BCC991C-7136-45DD-98E5-C29E2B2E64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2968C87-74F9-4AB2-8BF5-ECD5A0AEBD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235F51C-4B5B-4371-AF6F-BB671F296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61EC3-6C30-4757-98AB-147BBC8E8FEA}" type="datetimeFigureOut">
              <a:rPr lang="zh-CN" altLang="en-US" smtClean="0"/>
              <a:t>2019/2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9A4A065-093C-426B-ACBB-8483C99D77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19A59C3-7DD0-4569-8E41-48A72C29A9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DFE01-0A34-4BDF-86DB-42D91D210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184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8E2626-A2F2-4851-BD5C-A741C1873D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6BADD0D-A8A7-45AC-B718-CAFBF861338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6942866-75A9-4FB8-8E77-5C060E43FA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9423F41-6963-4108-B40B-9FAB7C6D8C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61EC3-6C30-4757-98AB-147BBC8E8FEA}" type="datetimeFigureOut">
              <a:rPr lang="zh-CN" altLang="en-US" smtClean="0"/>
              <a:t>2019/2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F7C0DF8-2C47-488D-ABDF-EAADE68C8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C00B8B1-946D-48EE-A2F5-6046EA976B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2DFE01-0A34-4BDF-86DB-42D91D210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1145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0CCB519-37B7-40CA-A266-FD13E94318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B67F875-BA8A-4D9C-933C-5E395D96B6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C250EB-CEA1-4BF0-A94C-97DDB44364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C61EC3-6C30-4757-98AB-147BBC8E8FEA}" type="datetimeFigureOut">
              <a:rPr lang="zh-CN" altLang="en-US" smtClean="0"/>
              <a:t>2019/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A462313-FF31-4057-8B54-C320137DC40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A7E5E0-69A2-4E57-AD76-4C40C36C3E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2DFE01-0A34-4BDF-86DB-42D91D210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9733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840832E-C27B-47D2-8CA8-3BC72BCF1E2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72949"/>
              </p:ext>
            </p:extLst>
          </p:nvPr>
        </p:nvGraphicFramePr>
        <p:xfrm>
          <a:off x="3258957" y="1420431"/>
          <a:ext cx="5674085" cy="484495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130991">
                  <a:extLst>
                    <a:ext uri="{9D8B030D-6E8A-4147-A177-3AD203B41FA5}">
                      <a16:colId xmlns:a16="http://schemas.microsoft.com/office/drawing/2014/main" val="3608991309"/>
                    </a:ext>
                  </a:extLst>
                </a:gridCol>
                <a:gridCol w="2130991">
                  <a:extLst>
                    <a:ext uri="{9D8B030D-6E8A-4147-A177-3AD203B41FA5}">
                      <a16:colId xmlns:a16="http://schemas.microsoft.com/office/drawing/2014/main" val="1104890707"/>
                    </a:ext>
                  </a:extLst>
                </a:gridCol>
                <a:gridCol w="1412103">
                  <a:extLst>
                    <a:ext uri="{9D8B030D-6E8A-4147-A177-3AD203B41FA5}">
                      <a16:colId xmlns:a16="http://schemas.microsoft.com/office/drawing/2014/main" val="2883718014"/>
                    </a:ext>
                  </a:extLst>
                </a:gridCol>
              </a:tblGrid>
              <a:tr h="286773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s　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(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3285001"/>
                  </a:ext>
                </a:extLst>
              </a:tr>
              <a:tr h="28677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60 year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(50.91)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3510151"/>
                  </a:ext>
                </a:extLst>
              </a:tr>
              <a:tr h="28677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60 year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(40.09)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7806503"/>
                  </a:ext>
                </a:extLst>
              </a:tr>
              <a:tr h="28677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de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(69.09)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8828613"/>
                  </a:ext>
                </a:extLst>
              </a:tr>
              <a:tr h="28677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(30.91)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8228588"/>
                  </a:ext>
                </a:extLst>
              </a:tr>
              <a:tr h="54336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pressio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(61.82)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7899713"/>
                  </a:ext>
                </a:extLst>
              </a:tr>
              <a:tr h="28677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(38.18)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3962897"/>
                  </a:ext>
                </a:extLst>
              </a:tr>
              <a:tr h="28677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M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, II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(25.45)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4950116"/>
                  </a:ext>
                </a:extLst>
              </a:tr>
              <a:tr h="28677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I, I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(74.55)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98345"/>
                  </a:ext>
                </a:extLst>
              </a:tr>
              <a:tr h="28677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(35.45)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1752343"/>
                  </a:ext>
                </a:extLst>
              </a:tr>
              <a:tr h="28677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</a:t>
                      </a:r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(64.55)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4366810"/>
                  </a:ext>
                </a:extLst>
              </a:tr>
              <a:tr h="286773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d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(2.73)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2715911"/>
                  </a:ext>
                </a:extLst>
              </a:tr>
              <a:tr h="28677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(25.45)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6793859"/>
                  </a:ext>
                </a:extLst>
              </a:tr>
              <a:tr h="28677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(53.64)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8975389"/>
                  </a:ext>
                </a:extLst>
              </a:tr>
              <a:tr h="28677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(18.18)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9578708"/>
                  </a:ext>
                </a:extLst>
              </a:tr>
              <a:tr h="286773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an of follow-up (month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(1~106)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4593922"/>
                  </a:ext>
                </a:extLst>
              </a:tr>
            </a:tbl>
          </a:graphicData>
        </a:graphic>
      </p:graphicFrame>
      <p:sp>
        <p:nvSpPr>
          <p:cNvPr id="5" name="矩形 4">
            <a:extLst>
              <a:ext uri="{FF2B5EF4-FFF2-40B4-BE49-F238E27FC236}">
                <a16:creationId xmlns:a16="http://schemas.microsoft.com/office/drawing/2014/main" id="{18990EC2-6331-45FF-B268-4034590B0149}"/>
              </a:ext>
            </a:extLst>
          </p:cNvPr>
          <p:cNvSpPr/>
          <p:nvPr/>
        </p:nvSpPr>
        <p:spPr>
          <a:xfrm>
            <a:off x="3258957" y="1065749"/>
            <a:ext cx="51191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The baseline characteristics of investigated GC patients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48017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1DE04AE8-D2A4-4678-910E-A1BD2C3A95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3668914"/>
              </p:ext>
            </p:extLst>
          </p:nvPr>
        </p:nvGraphicFramePr>
        <p:xfrm>
          <a:off x="3236794" y="2187054"/>
          <a:ext cx="5718411" cy="24838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10078">
                  <a:extLst>
                    <a:ext uri="{9D8B030D-6E8A-4147-A177-3AD203B41FA5}">
                      <a16:colId xmlns:a16="http://schemas.microsoft.com/office/drawing/2014/main" val="1141901884"/>
                    </a:ext>
                  </a:extLst>
                </a:gridCol>
                <a:gridCol w="810078">
                  <a:extLst>
                    <a:ext uri="{9D8B030D-6E8A-4147-A177-3AD203B41FA5}">
                      <a16:colId xmlns:a16="http://schemas.microsoft.com/office/drawing/2014/main" val="1550725006"/>
                    </a:ext>
                  </a:extLst>
                </a:gridCol>
                <a:gridCol w="824806">
                  <a:extLst>
                    <a:ext uri="{9D8B030D-6E8A-4147-A177-3AD203B41FA5}">
                      <a16:colId xmlns:a16="http://schemas.microsoft.com/office/drawing/2014/main" val="1970171007"/>
                    </a:ext>
                  </a:extLst>
                </a:gridCol>
                <a:gridCol w="810078">
                  <a:extLst>
                    <a:ext uri="{9D8B030D-6E8A-4147-A177-3AD203B41FA5}">
                      <a16:colId xmlns:a16="http://schemas.microsoft.com/office/drawing/2014/main" val="1614740021"/>
                    </a:ext>
                  </a:extLst>
                </a:gridCol>
                <a:gridCol w="828489">
                  <a:extLst>
                    <a:ext uri="{9D8B030D-6E8A-4147-A177-3AD203B41FA5}">
                      <a16:colId xmlns:a16="http://schemas.microsoft.com/office/drawing/2014/main" val="553178269"/>
                    </a:ext>
                  </a:extLst>
                </a:gridCol>
                <a:gridCol w="839534">
                  <a:extLst>
                    <a:ext uri="{9D8B030D-6E8A-4147-A177-3AD203B41FA5}">
                      <a16:colId xmlns:a16="http://schemas.microsoft.com/office/drawing/2014/main" val="611868124"/>
                    </a:ext>
                  </a:extLst>
                </a:gridCol>
                <a:gridCol w="795348">
                  <a:extLst>
                    <a:ext uri="{9D8B030D-6E8A-4147-A177-3AD203B41FA5}">
                      <a16:colId xmlns:a16="http://schemas.microsoft.com/office/drawing/2014/main" val="1122872856"/>
                    </a:ext>
                  </a:extLst>
                </a:gridCol>
              </a:tblGrid>
              <a:tr h="6209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ameter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 CI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toff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nsitivit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ificit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4597021"/>
                  </a:ext>
                </a:extLst>
              </a:tr>
              <a:tr h="6209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L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–0.77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1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.81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35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4452830"/>
                  </a:ext>
                </a:extLst>
              </a:tr>
              <a:tr h="6209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M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–0.7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.71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12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3742085"/>
                  </a:ext>
                </a:extLst>
              </a:tr>
              <a:tr h="6209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–0.9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.05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.57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8808121"/>
                  </a:ext>
                </a:extLst>
              </a:tr>
            </a:tbl>
          </a:graphicData>
        </a:graphic>
      </p:graphicFrame>
      <p:sp>
        <p:nvSpPr>
          <p:cNvPr id="5" name="矩形 4">
            <a:extLst>
              <a:ext uri="{FF2B5EF4-FFF2-40B4-BE49-F238E27FC236}">
                <a16:creationId xmlns:a16="http://schemas.microsoft.com/office/drawing/2014/main" id="{B5628B4B-3CE6-4BFB-A05E-08AE2C8FFFE9}"/>
              </a:ext>
            </a:extLst>
          </p:cNvPr>
          <p:cNvSpPr/>
          <p:nvPr/>
        </p:nvSpPr>
        <p:spPr>
          <a:xfrm>
            <a:off x="3236794" y="1814311"/>
            <a:ext cx="523822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. The cutoff of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LR, and LMR  determined by RO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40844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88450159-29AD-45AD-8722-CD0A881CE2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7609827"/>
              </p:ext>
            </p:extLst>
          </p:nvPr>
        </p:nvGraphicFramePr>
        <p:xfrm>
          <a:off x="2999136" y="2049485"/>
          <a:ext cx="6193728" cy="312857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65748">
                  <a:extLst>
                    <a:ext uri="{9D8B030D-6E8A-4147-A177-3AD203B41FA5}">
                      <a16:colId xmlns:a16="http://schemas.microsoft.com/office/drawing/2014/main" val="4028206096"/>
                    </a:ext>
                  </a:extLst>
                </a:gridCol>
                <a:gridCol w="1282626">
                  <a:extLst>
                    <a:ext uri="{9D8B030D-6E8A-4147-A177-3AD203B41FA5}">
                      <a16:colId xmlns:a16="http://schemas.microsoft.com/office/drawing/2014/main" val="4274995856"/>
                    </a:ext>
                  </a:extLst>
                </a:gridCol>
                <a:gridCol w="1215118">
                  <a:extLst>
                    <a:ext uri="{9D8B030D-6E8A-4147-A177-3AD203B41FA5}">
                      <a16:colId xmlns:a16="http://schemas.microsoft.com/office/drawing/2014/main" val="1069741013"/>
                    </a:ext>
                  </a:extLst>
                </a:gridCol>
                <a:gridCol w="1215118">
                  <a:extLst>
                    <a:ext uri="{9D8B030D-6E8A-4147-A177-3AD203B41FA5}">
                      <a16:colId xmlns:a16="http://schemas.microsoft.com/office/drawing/2014/main" val="1780848399"/>
                    </a:ext>
                  </a:extLst>
                </a:gridCol>
                <a:gridCol w="1215118">
                  <a:extLst>
                    <a:ext uri="{9D8B030D-6E8A-4147-A177-3AD203B41FA5}">
                      <a16:colId xmlns:a16="http://schemas.microsoft.com/office/drawing/2014/main" val="3821168245"/>
                    </a:ext>
                  </a:extLst>
                </a:gridCol>
              </a:tblGrid>
              <a:tr h="391072"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0% CI for R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4988067"/>
                  </a:ext>
                </a:extLst>
              </a:tr>
              <a:tr h="39107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pp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1966990"/>
                  </a:ext>
                </a:extLst>
              </a:tr>
              <a:tr h="391072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96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5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938897"/>
                  </a:ext>
                </a:extLst>
              </a:tr>
              <a:tr h="391072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d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8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0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7624070"/>
                  </a:ext>
                </a:extLst>
              </a:tr>
              <a:tr h="391072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d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83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5652831"/>
                  </a:ext>
                </a:extLst>
              </a:tr>
              <a:tr h="391072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DD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4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5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21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5753980"/>
                  </a:ext>
                </a:extLst>
              </a:tr>
              <a:tr h="391072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N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9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3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601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2913556"/>
                  </a:ext>
                </a:extLst>
              </a:tr>
              <a:tr h="391072"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7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5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2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0034572"/>
                  </a:ext>
                </a:extLst>
              </a:tr>
            </a:tbl>
          </a:graphicData>
        </a:graphic>
      </p:graphicFrame>
      <p:sp>
        <p:nvSpPr>
          <p:cNvPr id="5" name="矩形 4">
            <a:extLst>
              <a:ext uri="{FF2B5EF4-FFF2-40B4-BE49-F238E27FC236}">
                <a16:creationId xmlns:a16="http://schemas.microsoft.com/office/drawing/2014/main" id="{3B6099D8-B843-43D0-967D-5ABBE35C469D}"/>
              </a:ext>
            </a:extLst>
          </p:cNvPr>
          <p:cNvSpPr/>
          <p:nvPr/>
        </p:nvSpPr>
        <p:spPr>
          <a:xfrm>
            <a:off x="2999136" y="1679939"/>
            <a:ext cx="60692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JansonText-Roman"/>
              </a:rPr>
              <a:t>Supplementary table 3. Univariate Cox regression analysis of factors associated with OS of GC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1182024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F8B03E3B-A78F-49D5-BD69-86A22B97EB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809065"/>
              </p:ext>
            </p:extLst>
          </p:nvPr>
        </p:nvGraphicFramePr>
        <p:xfrm>
          <a:off x="3330994" y="2286000"/>
          <a:ext cx="5231219" cy="2286000"/>
        </p:xfrm>
        <a:graphic>
          <a:graphicData uri="http://schemas.openxmlformats.org/drawingml/2006/table">
            <a:tbl>
              <a:tblPr firstRow="1" firstCol="1" bandRow="1">
                <a:tableStyleId>{3B4B98B0-60AC-42C2-AFA5-B58CD77FA1E5}</a:tableStyleId>
              </a:tblPr>
              <a:tblGrid>
                <a:gridCol w="1244319">
                  <a:extLst>
                    <a:ext uri="{9D8B030D-6E8A-4147-A177-3AD203B41FA5}">
                      <a16:colId xmlns:a16="http://schemas.microsoft.com/office/drawing/2014/main" val="3675389833"/>
                    </a:ext>
                  </a:extLst>
                </a:gridCol>
                <a:gridCol w="1134314">
                  <a:extLst>
                    <a:ext uri="{9D8B030D-6E8A-4147-A177-3AD203B41FA5}">
                      <a16:colId xmlns:a16="http://schemas.microsoft.com/office/drawing/2014/main" val="1555666288"/>
                    </a:ext>
                  </a:extLst>
                </a:gridCol>
                <a:gridCol w="1134314">
                  <a:extLst>
                    <a:ext uri="{9D8B030D-6E8A-4147-A177-3AD203B41FA5}">
                      <a16:colId xmlns:a16="http://schemas.microsoft.com/office/drawing/2014/main" val="2567178741"/>
                    </a:ext>
                  </a:extLst>
                </a:gridCol>
                <a:gridCol w="871850">
                  <a:extLst>
                    <a:ext uri="{9D8B030D-6E8A-4147-A177-3AD203B41FA5}">
                      <a16:colId xmlns:a16="http://schemas.microsoft.com/office/drawing/2014/main" val="99782347"/>
                    </a:ext>
                  </a:extLst>
                </a:gridCol>
                <a:gridCol w="846422">
                  <a:extLst>
                    <a:ext uri="{9D8B030D-6E8A-4147-A177-3AD203B41FA5}">
                      <a16:colId xmlns:a16="http://schemas.microsoft.com/office/drawing/2014/main" val="3447478190"/>
                    </a:ext>
                  </a:extLst>
                </a:gridCol>
              </a:tblGrid>
              <a:tr h="457200">
                <a:tc rowSpan="2"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tors</a:t>
                      </a:r>
                      <a:endParaRPr lang="en-US" sz="1200" b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-US" sz="1200" b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</a:t>
                      </a:r>
                      <a:endParaRPr lang="en-US" sz="1200" b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 (95.0% CI)</a:t>
                      </a:r>
                      <a:endParaRPr lang="en-US" sz="1200" b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61843370"/>
                  </a:ext>
                </a:extLst>
              </a:tr>
              <a:tr h="457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er</a:t>
                      </a:r>
                      <a:endParaRPr lang="en-US" sz="1200" b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pper</a:t>
                      </a:r>
                      <a:endParaRPr lang="en-US" sz="1200" b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7868838"/>
                  </a:ext>
                </a:extLst>
              </a:tr>
              <a:tr h="457200"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DD</a:t>
                      </a:r>
                      <a:endParaRPr lang="en-US" sz="1200" b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  <a:endParaRPr lang="en-US" sz="1200" b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9</a:t>
                      </a:r>
                      <a:endParaRPr lang="en-US" sz="1200" b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5</a:t>
                      </a:r>
                      <a:endParaRPr lang="en-US" sz="1200" b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4</a:t>
                      </a:r>
                      <a:endParaRPr lang="en-US" sz="1200" b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340526"/>
                  </a:ext>
                </a:extLst>
              </a:tr>
              <a:tr h="457200"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M</a:t>
                      </a:r>
                      <a:endParaRPr lang="en-US" sz="1200" b="0" u="none" strike="noStrike" kern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5</a:t>
                      </a:r>
                      <a:endParaRPr lang="en-US" sz="1200" b="0" u="none" strike="noStrike" kern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2</a:t>
                      </a:r>
                      <a:endParaRPr lang="en-US" sz="1200" b="0" u="none" strike="noStrike" kern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</a:t>
                      </a:r>
                      <a:endParaRPr lang="en-US" sz="1200" b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7</a:t>
                      </a:r>
                      <a:endParaRPr lang="en-US" sz="1200" b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9951288"/>
                  </a:ext>
                </a:extLst>
              </a:tr>
              <a:tr h="457200"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N</a:t>
                      </a:r>
                      <a:endParaRPr lang="en-US" sz="1200" b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  <a:endParaRPr lang="en-US" sz="1200" b="0" u="none" strike="noStrike" kern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3</a:t>
                      </a:r>
                      <a:endParaRPr lang="en-US" sz="1200" b="0" u="none" strike="noStrike" kern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4</a:t>
                      </a:r>
                      <a:endParaRPr lang="en-US" sz="1200" b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u="none" strike="noStrike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3</a:t>
                      </a:r>
                      <a:endParaRPr lang="en-US" sz="1200" b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1387006"/>
                  </a:ext>
                </a:extLst>
              </a:tr>
            </a:tbl>
          </a:graphicData>
        </a:graphic>
      </p:graphicFrame>
      <p:sp>
        <p:nvSpPr>
          <p:cNvPr id="6" name="矩形 5">
            <a:extLst>
              <a:ext uri="{FF2B5EF4-FFF2-40B4-BE49-F238E27FC236}">
                <a16:creationId xmlns:a16="http://schemas.microsoft.com/office/drawing/2014/main" id="{969CA120-DAB0-4B1C-B2D3-578E2B3CE9AA}"/>
              </a:ext>
            </a:extLst>
          </p:cNvPr>
          <p:cNvSpPr/>
          <p:nvPr/>
        </p:nvSpPr>
        <p:spPr>
          <a:xfrm>
            <a:off x="3235301" y="1798606"/>
            <a:ext cx="6096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Table 4.</a:t>
            </a:r>
            <a:r>
              <a:rPr lang="en-US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Multivariate analysis of factors affecting OS of GC patients</a:t>
            </a:r>
            <a:endParaRPr lang="en-US" sz="12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30950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D3F11FF-9785-4F17-A2F6-01D8D0272F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6094515"/>
              </p:ext>
            </p:extLst>
          </p:nvPr>
        </p:nvGraphicFramePr>
        <p:xfrm>
          <a:off x="3557795" y="2352337"/>
          <a:ext cx="5258908" cy="257771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59553">
                  <a:extLst>
                    <a:ext uri="{9D8B030D-6E8A-4147-A177-3AD203B41FA5}">
                      <a16:colId xmlns:a16="http://schemas.microsoft.com/office/drawing/2014/main" val="1889696094"/>
                    </a:ext>
                  </a:extLst>
                </a:gridCol>
                <a:gridCol w="656715">
                  <a:extLst>
                    <a:ext uri="{9D8B030D-6E8A-4147-A177-3AD203B41FA5}">
                      <a16:colId xmlns:a16="http://schemas.microsoft.com/office/drawing/2014/main" val="64172530"/>
                    </a:ext>
                  </a:extLst>
                </a:gridCol>
                <a:gridCol w="857792">
                  <a:extLst>
                    <a:ext uri="{9D8B030D-6E8A-4147-A177-3AD203B41FA5}">
                      <a16:colId xmlns:a16="http://schemas.microsoft.com/office/drawing/2014/main" val="2717697202"/>
                    </a:ext>
                  </a:extLst>
                </a:gridCol>
                <a:gridCol w="752464">
                  <a:extLst>
                    <a:ext uri="{9D8B030D-6E8A-4147-A177-3AD203B41FA5}">
                      <a16:colId xmlns:a16="http://schemas.microsoft.com/office/drawing/2014/main" val="3962882257"/>
                    </a:ext>
                  </a:extLst>
                </a:gridCol>
                <a:gridCol w="1116192">
                  <a:extLst>
                    <a:ext uri="{9D8B030D-6E8A-4147-A177-3AD203B41FA5}">
                      <a16:colId xmlns:a16="http://schemas.microsoft.com/office/drawing/2014/main" val="2690477959"/>
                    </a:ext>
                  </a:extLst>
                </a:gridCol>
                <a:gridCol w="1116192">
                  <a:extLst>
                    <a:ext uri="{9D8B030D-6E8A-4147-A177-3AD203B41FA5}">
                      <a16:colId xmlns:a16="http://schemas.microsoft.com/office/drawing/2014/main" val="1161012024"/>
                    </a:ext>
                  </a:extLst>
                </a:gridCol>
              </a:tblGrid>
              <a:tr h="574477"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s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M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N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de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pression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8592518"/>
                  </a:ext>
                </a:extLst>
              </a:tr>
              <a:tr h="574477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LR</a:t>
                      </a:r>
                      <a:endParaRPr lang="en-US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en-US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</a:t>
                      </a:r>
                      <a:r>
                        <a:rPr lang="en-US" sz="1200" b="0" kern="1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</a:t>
                      </a:r>
                      <a:r>
                        <a:rPr lang="en-US" sz="1200" b="0" kern="1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8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</a:t>
                      </a:r>
                      <a:r>
                        <a:rPr lang="en-US" sz="1200" b="0" kern="100" baseline="30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lang="en-US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5616107"/>
                  </a:ext>
                </a:extLst>
              </a:tr>
              <a:tr h="27980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-US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en-US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en-US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en-US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0951327"/>
                  </a:ext>
                </a:extLst>
              </a:tr>
              <a:tr h="869151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MR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7</a:t>
                      </a:r>
                      <a:r>
                        <a:rPr lang="en-US" sz="1200" b="0" kern="100" baseline="30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lang="en-US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5</a:t>
                      </a:r>
                      <a:r>
                        <a:rPr lang="en-US" sz="1200" b="0" kern="100" baseline="30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lang="en-US" sz="11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5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1</a:t>
                      </a:r>
                      <a:r>
                        <a:rPr lang="en-US" sz="1200" b="0" kern="1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2775252"/>
                  </a:ext>
                </a:extLst>
              </a:tr>
              <a:tr h="27980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0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en-US" sz="11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9525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9382162"/>
                  </a:ext>
                </a:extLst>
              </a:tr>
            </a:tbl>
          </a:graphicData>
        </a:graphic>
      </p:graphicFrame>
      <p:sp>
        <p:nvSpPr>
          <p:cNvPr id="5" name="矩形 4">
            <a:extLst>
              <a:ext uri="{FF2B5EF4-FFF2-40B4-BE49-F238E27FC236}">
                <a16:creationId xmlns:a16="http://schemas.microsoft.com/office/drawing/2014/main" id="{6534CF80-E38A-4994-91BE-8AB1B030B04B}"/>
              </a:ext>
            </a:extLst>
          </p:cNvPr>
          <p:cNvSpPr/>
          <p:nvPr/>
        </p:nvSpPr>
        <p:spPr>
          <a:xfrm>
            <a:off x="3337391" y="1917253"/>
            <a:ext cx="6096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5. Correlation of NLR and LMR with clinical characteristics of GC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83709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FD3C9AD-BDAA-4FB3-9F83-8828A8F97BC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1932" y="-1"/>
            <a:ext cx="7267990" cy="6411579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9DA40292-A8FB-4447-B67F-BD36E5767680}"/>
              </a:ext>
            </a:extLst>
          </p:cNvPr>
          <p:cNvSpPr/>
          <p:nvPr/>
        </p:nvSpPr>
        <p:spPr>
          <a:xfrm>
            <a:off x="142874" y="6441395"/>
            <a:ext cx="1206610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a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L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correlated with inflammation signaling pathway in patients with GC. b. and high levels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L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T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associated with poor OS of GC patients</a:t>
            </a:r>
          </a:p>
        </p:txBody>
      </p:sp>
    </p:spTree>
    <p:extLst>
      <p:ext uri="{BB962C8B-B14F-4D97-AF65-F5344CB8AC3E}">
        <p14:creationId xmlns:p14="http://schemas.microsoft.com/office/powerpoint/2010/main" val="6612481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8F74485C-878C-47CB-A8AA-C9EC68597162}"/>
              </a:ext>
            </a:extLst>
          </p:cNvPr>
          <p:cNvSpPr/>
          <p:nvPr/>
        </p:nvSpPr>
        <p:spPr>
          <a:xfrm>
            <a:off x="2723321" y="6224948"/>
            <a:ext cx="723568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a. CMS led to depressive like behaviors of mice. b and c. CMS induced dysregulated inflammation factors and ROS.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EE462BCB-C967-4B97-A482-6993E28B38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1556" y="40140"/>
            <a:ext cx="6440557" cy="6015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3681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9</TotalTime>
  <Words>340</Words>
  <Application>Microsoft Office PowerPoint</Application>
  <PresentationFormat>宽屏</PresentationFormat>
  <Paragraphs>157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3" baseType="lpstr">
      <vt:lpstr>DengXian</vt:lpstr>
      <vt:lpstr>DengXian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</dc:creator>
  <cp:lastModifiedBy>Xiaohan Yuan</cp:lastModifiedBy>
  <cp:revision>39</cp:revision>
  <dcterms:created xsi:type="dcterms:W3CDTF">2017-12-09T07:51:26Z</dcterms:created>
  <dcterms:modified xsi:type="dcterms:W3CDTF">2019-03-01T04:08:43Z</dcterms:modified>
</cp:coreProperties>
</file>